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8" d="100"/>
          <a:sy n="98" d="100"/>
        </p:scale>
        <p:origin x="-576" y="-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C8D535-F328-455E-8A4F-F99779765C08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F37A20-B5D6-4499-BC6E-A95FB667F1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79837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dirty="0" smtClean="0"/>
              <a:t>Fluorescent identify result</a:t>
            </a:r>
            <a:r>
              <a:rPr lang="en-US" altLang="zh-CN" sz="1200" b="1" baseline="0" dirty="0" smtClean="0"/>
              <a:t> </a:t>
            </a:r>
            <a:r>
              <a:rPr lang="en-US" altLang="zh-CN" sz="1200" b="1" dirty="0" smtClean="0"/>
              <a:t>showed that all these</a:t>
            </a:r>
            <a:r>
              <a:rPr lang="en-US" altLang="zh-CN" sz="1200" b="1" baseline="0" dirty="0" smtClean="0"/>
              <a:t> </a:t>
            </a:r>
            <a:r>
              <a:rPr lang="en-US" altLang="zh-CN" sz="1200" b="1" dirty="0" smtClean="0"/>
              <a:t>recombinant plasmids were</a:t>
            </a:r>
            <a:r>
              <a:rPr lang="en-US" altLang="zh-CN" sz="1200" b="1" baseline="0" dirty="0" smtClean="0"/>
              <a:t> correctly constructed.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bright green fluorescence was observed from these recombinant plasmids-transfected cells, although the expression efficiency of each recombinant plasmid is different due to individual gene specificity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F37A20-B5D6-4499-BC6E-A95FB667F1E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15641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4255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3655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6048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3357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3035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3371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5079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7049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9198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986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5679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D0C9B-DFD4-4B1C-B89A-421629DCFCF3}" type="datetimeFigureOut">
              <a:rPr lang="zh-CN" altLang="en-US" smtClean="0"/>
              <a:t>2018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F359BF-BB87-4FFD-9749-5373F7BE5A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8773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26" Type="http://schemas.openxmlformats.org/officeDocument/2006/relationships/image" Target="../media/image24.jpeg"/><Relationship Id="rId3" Type="http://schemas.openxmlformats.org/officeDocument/2006/relationships/image" Target="../media/image1.tiff"/><Relationship Id="rId21" Type="http://schemas.openxmlformats.org/officeDocument/2006/relationships/image" Target="../media/image19.tiff"/><Relationship Id="rId7" Type="http://schemas.openxmlformats.org/officeDocument/2006/relationships/image" Target="../media/image5.jpeg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5" Type="http://schemas.openxmlformats.org/officeDocument/2006/relationships/image" Target="../media/image23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tiff"/><Relationship Id="rId29" Type="http://schemas.openxmlformats.org/officeDocument/2006/relationships/image" Target="../media/image2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24" Type="http://schemas.openxmlformats.org/officeDocument/2006/relationships/image" Target="../media/image22.tiff"/><Relationship Id="rId5" Type="http://schemas.openxmlformats.org/officeDocument/2006/relationships/image" Target="../media/image3.tiff"/><Relationship Id="rId15" Type="http://schemas.openxmlformats.org/officeDocument/2006/relationships/image" Target="../media/image13.jpeg"/><Relationship Id="rId23" Type="http://schemas.openxmlformats.org/officeDocument/2006/relationships/image" Target="../media/image21.tiff"/><Relationship Id="rId28" Type="http://schemas.openxmlformats.org/officeDocument/2006/relationships/image" Target="../media/image26.tiff"/><Relationship Id="rId10" Type="http://schemas.openxmlformats.org/officeDocument/2006/relationships/image" Target="../media/image8.tiff"/><Relationship Id="rId19" Type="http://schemas.openxmlformats.org/officeDocument/2006/relationships/image" Target="../media/image17.jpeg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Relationship Id="rId22" Type="http://schemas.openxmlformats.org/officeDocument/2006/relationships/image" Target="../media/image20.tiff"/><Relationship Id="rId27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409799" y="491145"/>
            <a:ext cx="6024692" cy="6061118"/>
            <a:chOff x="1409799" y="491145"/>
            <a:chExt cx="6024692" cy="6061118"/>
          </a:xfrm>
        </p:grpSpPr>
        <p:pic>
          <p:nvPicPr>
            <p:cNvPr id="1026" name="Picture 2" descr="C:\Users\YF\Desktop\M-2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13821" y="3493450"/>
              <a:ext cx="1497966" cy="10205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" name="组合 5"/>
            <p:cNvGrpSpPr/>
            <p:nvPr/>
          </p:nvGrpSpPr>
          <p:grpSpPr>
            <a:xfrm>
              <a:off x="1409799" y="491145"/>
              <a:ext cx="6024692" cy="6061118"/>
              <a:chOff x="1933080" y="495930"/>
              <a:chExt cx="5328971" cy="4862099"/>
            </a:xfrm>
          </p:grpSpPr>
          <p:pic>
            <p:nvPicPr>
              <p:cNvPr id="2086" name="Picture 38" descr="C:\Users\YF\Desktop\新建文件夹 (3)\16.tif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32201" y="3732899"/>
                <a:ext cx="1329850" cy="81314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0" name="Picture 2" descr="C:\Users\YF\Desktop\新建文件夹 (3)\4.tif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39689" y="495930"/>
                <a:ext cx="1321932" cy="78735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1" name="Picture 3" descr="C:\Users\YF\Desktop\新建文件夹 (3)\1.tif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97251" y="4564412"/>
                <a:ext cx="1326207" cy="78564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3" name="Picture 5" descr="C:\Users\YF\Desktop\新建文件夹 (3)\3.tif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32891" y="495931"/>
                <a:ext cx="1329159" cy="78735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4" name="Picture 6" descr="C:\Users\YF\Desktop\新建文件夹 (3)\8.tif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37099" y="1289480"/>
                <a:ext cx="1324523" cy="78564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5" name="Picture 7" descr="C:\Users\YF\Desktop\新建文件夹 (3)\5.tif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32891" y="1289480"/>
                <a:ext cx="1329160" cy="78564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6" name="Picture 8" descr="C:\Users\YF\Desktop\新建文件夹 (3)\6.tif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04355" y="1289481"/>
                <a:ext cx="1319103" cy="78564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7" name="Picture 9" descr="C:\Users\YF\Desktop\新建文件夹 (3)\7.tif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74769" y="1289481"/>
                <a:ext cx="1321934" cy="78564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62" name="Picture 14" descr="C:\Users\YF\Desktop\新建文件夹 (3)\12.tif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32682" y="2083226"/>
                <a:ext cx="1329369" cy="81264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63" name="Picture 15" descr="C:\Users\YF\Desktop\新建文件夹 (3)\9.tif"/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04355" y="2083226"/>
                <a:ext cx="1319103" cy="81264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64" name="Picture 16" descr="C:\Users\YF\Desktop\新建文件夹 (3)\10.tif"/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74769" y="2083226"/>
                <a:ext cx="1321935" cy="81264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65" name="Picture 17" descr="C:\Users\YF\Desktop\新建文件夹 (3)\11.jpg"/>
              <p:cNvPicPr>
                <a:picLocks noChangeAspect="1" noChangeArrowheads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33080" y="2083226"/>
                <a:ext cx="1328543" cy="81264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67" name="Picture 19" descr="C:\Users\YF\Desktop\新建文件夹 (3)\13.jpg"/>
              <p:cNvPicPr>
                <a:picLocks noChangeAspect="1" noChangeArrowheads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74769" y="2904315"/>
                <a:ext cx="1321934" cy="81865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72" name="Picture 24" descr="C:\Users\YF\Desktop\新建文件夹 (3)\N.tif"/>
              <p:cNvPicPr>
                <a:picLocks noChangeAspect="1" noChangeArrowheads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32891" y="2903940"/>
                <a:ext cx="1329160" cy="81692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73" name="Picture 25" descr="C:\Users\YF\Desktop\新建文件夹 (3)\EN.tif"/>
              <p:cNvPicPr>
                <a:picLocks noChangeAspect="1" noChangeArrowheads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04355" y="2904315"/>
                <a:ext cx="1319103" cy="81865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77" name="Picture 29" descr="C:\Users\YF\Desktop\新建文件夹 (3)\GFP-SS1.jpg"/>
              <p:cNvPicPr>
                <a:picLocks noChangeAspect="1" noChangeArrowheads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26156" y="2650541"/>
                <a:ext cx="38523" cy="2339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78" name="Picture 30" descr="C:\Users\YF\Desktop\新建文件夹 (3)\M.tif"/>
              <p:cNvPicPr>
                <a:picLocks noChangeAspect="1" noChangeArrowheads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38650" y="2658338"/>
                <a:ext cx="14576" cy="866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79" name="Picture 31" descr="C:\Users\YF\Desktop\新建文件夹 (3)\N.tif"/>
              <p:cNvPicPr>
                <a:picLocks noChangeAspect="1" noChangeArrowheads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38650" y="2658338"/>
                <a:ext cx="14576" cy="866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80" name="Picture 32" descr="C:\Users\YF\Desktop\新建文件夹 (3)\S2.tif"/>
              <p:cNvPicPr>
                <a:picLocks noChangeAspect="1" noChangeArrowheads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38650" y="2658338"/>
                <a:ext cx="14576" cy="866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7" name="Picture 26" descr="C:\Users\YF\Desktop\新建文件夹 (3)\ORF3.tif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75856" y="4564411"/>
                <a:ext cx="1320847" cy="79361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8" name="Picture 27" descr="C:\Users\YF\Desktop\新建文件夹 (3)\EN.tif"/>
              <p:cNvPicPr>
                <a:picLocks noChangeAspect="1" noChangeArrowheads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33233" y="4564411"/>
                <a:ext cx="1328390" cy="79361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9" name="Picture 28" descr="C:\Users\YF\Desktop\新建文件夹 (3)\GFP.tif"/>
              <p:cNvPicPr>
                <a:picLocks noChangeAspect="1" noChangeArrowheads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72009" y="495930"/>
                <a:ext cx="1323860" cy="78735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0" name="Picture 33" descr="C:\Users\YF\Desktop\新建文件夹 (3)\GFP-SS1.jpg"/>
              <p:cNvPicPr>
                <a:picLocks noChangeAspect="1" noChangeArrowheads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33233" y="3732900"/>
                <a:ext cx="1328390" cy="81314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1" name="Picture 34" descr="C:\Users\YF\Desktop\新建文件夹 (3)\M.tif"/>
              <p:cNvPicPr>
                <a:picLocks noChangeAspect="1" noChangeArrowheads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72928" y="3732899"/>
                <a:ext cx="1323775" cy="81314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3" name="Picture 36" descr="C:\Users\YF\Desktop\新建文件夹 (3)\S2.tif"/>
              <p:cNvPicPr>
                <a:picLocks noChangeAspect="1" noChangeArrowheads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04355" y="3732900"/>
                <a:ext cx="1319103" cy="81314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7" name="Picture 7" descr="F:\U\u盘\0802荧光\拍摄 20x SARS1-1.jpg"/>
              <p:cNvPicPr>
                <a:picLocks noChangeAspect="1" noChangeArrowheads="1"/>
              </p:cNvPicPr>
              <p:nvPr/>
            </p:nvPicPr>
            <p:blipFill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04636" y="495930"/>
                <a:ext cx="1318822" cy="78490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0" name="TextBox 49"/>
              <p:cNvSpPr txBox="1"/>
              <p:nvPr/>
            </p:nvSpPr>
            <p:spPr>
              <a:xfrm>
                <a:off x="1939689" y="1047961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1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3282003" y="1032369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2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4602939" y="1029863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3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1955859" y="1830529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5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5932824" y="1029254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4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284869" y="1828922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6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4611755" y="1822578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7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5916324" y="1830529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8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1955859" y="2650541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9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4604253" y="3471260"/>
                <a:ext cx="9050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15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4603804" y="2636912"/>
                <a:ext cx="7914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11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5940152" y="2636912"/>
                <a:ext cx="7920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12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3272009" y="2649651"/>
                <a:ext cx="83973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10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939508" y="3470811"/>
                <a:ext cx="845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13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3275856" y="3470811"/>
                <a:ext cx="8337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14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5932201" y="3470811"/>
                <a:ext cx="8386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SP16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1939508" y="4293096"/>
                <a:ext cx="8260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ORF3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3275856" y="4311054"/>
                <a:ext cx="10012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M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5932201" y="4287201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E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1939957" y="5102693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S1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3267905" y="5103142"/>
                <a:ext cx="7200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S2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4645821" y="5095191"/>
                <a:ext cx="5022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4595869" y="4293096"/>
                <a:ext cx="8724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bg1"/>
                    </a:solidFill>
                  </a:rPr>
                  <a:t>GFP-N</a:t>
                </a:r>
                <a:endParaRPr lang="zh-CN" altLang="en-US" sz="1000" dirty="0">
                  <a:solidFill>
                    <a:schemeClr val="bg1"/>
                  </a:solidFill>
                </a:endParaRPr>
              </a:p>
            </p:txBody>
          </p:sp>
        </p:grpSp>
      </p:grpSp>
      <p:sp>
        <p:nvSpPr>
          <p:cNvPr id="74" name="标题 1"/>
          <p:cNvSpPr>
            <a:spLocks noGrp="1"/>
          </p:cNvSpPr>
          <p:nvPr/>
        </p:nvSpPr>
        <p:spPr>
          <a:xfrm>
            <a:off x="1547663" y="-99392"/>
            <a:ext cx="5976665" cy="59053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fontAlgn="t"/>
            <a:r>
              <a:rPr lang="en-US" altLang="zh-CN" sz="1600" b="1" dirty="0" smtClean="0"/>
              <a:t>Fig. Fluorescent identify of recombinant plasmids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510999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21</TotalTime>
  <Words>72</Words>
  <Application>Microsoft Office PowerPoint</Application>
  <PresentationFormat>全屏显示(4:3)</PresentationFormat>
  <Paragraphs>26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F chen</dc:creator>
  <cp:lastModifiedBy>YF chen</cp:lastModifiedBy>
  <cp:revision>41</cp:revision>
  <dcterms:created xsi:type="dcterms:W3CDTF">2018-03-08T14:33:23Z</dcterms:created>
  <dcterms:modified xsi:type="dcterms:W3CDTF">2018-09-19T17:36:38Z</dcterms:modified>
</cp:coreProperties>
</file>